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39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3207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3581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9570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4178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5263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3330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5920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4160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358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0437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2896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83E01-AAA0-4138-BD9E-EB4E716DFAF5}" type="datetimeFigureOut">
              <a:rPr lang="fr-FR" smtClean="0"/>
              <a:t>19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3BEB4-E8B9-4DF8-9EE5-2A7EB6D7B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3281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4867943-5FD7-42F3-A604-0D521CF855FD}"/>
              </a:ext>
            </a:extLst>
          </p:cNvPr>
          <p:cNvSpPr/>
          <p:nvPr/>
        </p:nvSpPr>
        <p:spPr>
          <a:xfrm>
            <a:off x="948905" y="1835175"/>
            <a:ext cx="10161917" cy="23064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le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lomeric and sub-telomeric regions undergo rapid turnover within a </a:t>
            </a:r>
            <a:r>
              <a:rPr lang="en-US" sz="1400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eptomyces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opulation</a:t>
            </a:r>
            <a:endParaRPr lang="fr-FR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doul-</a:t>
            </a:r>
            <a:r>
              <a:rPr lang="fr-FR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zak</a:t>
            </a:r>
            <a:r>
              <a:rPr lang="fr-FR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djani</a:t>
            </a:r>
            <a:r>
              <a:rPr lang="fr-FR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fr-FR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yril Bontemps, Pierre Leblond</a:t>
            </a:r>
            <a:endParaRPr lang="fr-FR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fr-FR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iversité de Lorraine, INRAE, </a:t>
            </a:r>
            <a:r>
              <a:rPr lang="fr-FR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ynAMic</a:t>
            </a:r>
            <a:r>
              <a:rPr lang="fr-FR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F-54000 Nancy, France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15791172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Groupe 73"/>
          <p:cNvGrpSpPr/>
          <p:nvPr/>
        </p:nvGrpSpPr>
        <p:grpSpPr>
          <a:xfrm>
            <a:off x="332805" y="637947"/>
            <a:ext cx="649537" cy="1781980"/>
            <a:chOff x="-14861" y="642710"/>
            <a:chExt cx="649537" cy="1781980"/>
          </a:xfrm>
        </p:grpSpPr>
        <p:sp>
          <p:nvSpPr>
            <p:cNvPr id="2" name="ZoneTexte 1"/>
            <p:cNvSpPr txBox="1"/>
            <p:nvPr/>
          </p:nvSpPr>
          <p:spPr>
            <a:xfrm>
              <a:off x="106165" y="813511"/>
              <a:ext cx="40748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RLB1-8</a:t>
              </a:r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106165" y="904535"/>
              <a:ext cx="40748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RLB3-5</a:t>
              </a:r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91738" y="986034"/>
              <a:ext cx="43633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D4-14</a:t>
              </a:r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91738" y="1081819"/>
              <a:ext cx="43633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D4-20</a:t>
              </a:r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46053" y="1175223"/>
              <a:ext cx="527709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pS1D4-14.1</a:t>
              </a:r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-14861" y="1261484"/>
              <a:ext cx="64953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. </a:t>
              </a:r>
              <a:r>
                <a:rPr lang="fr-FR" sz="5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engpaensis</a:t>
              </a:r>
              <a:endParaRPr lang="fr-FR" sz="5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72502" y="1435491"/>
              <a:ext cx="47481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pS1D4-20</a:t>
              </a:r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106165" y="1651511"/>
              <a:ext cx="40748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RLB1-9</a:t>
              </a:r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109371" y="1745041"/>
              <a:ext cx="40107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A1-3</a:t>
              </a:r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109371" y="1833809"/>
              <a:ext cx="40107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A1-8</a:t>
              </a:r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28420" y="2040622"/>
              <a:ext cx="562975" cy="2048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. </a:t>
              </a:r>
              <a:r>
                <a:rPr lang="fr-FR" sz="5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oelicolor</a:t>
              </a:r>
              <a:endParaRPr lang="fr-FR" sz="5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60480" y="2134152"/>
              <a:ext cx="498855" cy="2048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. </a:t>
              </a:r>
              <a:r>
                <a:rPr lang="fr-FR" sz="5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ividans</a:t>
              </a:r>
              <a:endParaRPr lang="fr-FR" sz="5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20405" y="2219864"/>
              <a:ext cx="579005" cy="2048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. </a:t>
              </a:r>
              <a:r>
                <a:rPr lang="fr-FR" sz="5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vermitilis</a:t>
              </a:r>
              <a:endParaRPr lang="fr-FR" sz="5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Connecteur droit 11"/>
            <p:cNvCxnSpPr/>
            <p:nvPr/>
          </p:nvCxnSpPr>
          <p:spPr>
            <a:xfrm>
              <a:off x="309907" y="813511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56"/>
            <p:cNvCxnSpPr/>
            <p:nvPr/>
          </p:nvCxnSpPr>
          <p:spPr>
            <a:xfrm>
              <a:off x="85191" y="813511"/>
              <a:ext cx="44943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ZoneTexte 57"/>
            <p:cNvSpPr txBox="1"/>
            <p:nvPr/>
          </p:nvSpPr>
          <p:spPr>
            <a:xfrm>
              <a:off x="132182" y="642710"/>
              <a:ext cx="37542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err="1"/>
                <a:t>Strain</a:t>
              </a:r>
              <a:endParaRPr lang="fr-FR" sz="600" b="1" dirty="0"/>
            </a:p>
          </p:txBody>
        </p:sp>
      </p:grpSp>
      <p:grpSp>
        <p:nvGrpSpPr>
          <p:cNvPr id="73" name="Groupe 72"/>
          <p:cNvGrpSpPr/>
          <p:nvPr/>
        </p:nvGrpSpPr>
        <p:grpSpPr>
          <a:xfrm>
            <a:off x="-3558" y="552205"/>
            <a:ext cx="498855" cy="1463631"/>
            <a:chOff x="467934" y="556968"/>
            <a:chExt cx="498855" cy="1463631"/>
          </a:xfrm>
        </p:grpSpPr>
        <p:sp>
          <p:nvSpPr>
            <p:cNvPr id="59" name="ZoneTexte 58"/>
            <p:cNvSpPr txBox="1"/>
            <p:nvPr/>
          </p:nvSpPr>
          <p:spPr>
            <a:xfrm>
              <a:off x="467934" y="556968"/>
              <a:ext cx="4988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err="1"/>
                <a:t>Telomere</a:t>
              </a:r>
              <a:endParaRPr lang="fr-FR" sz="600" b="1" dirty="0"/>
            </a:p>
            <a:p>
              <a:r>
                <a:rPr lang="fr-FR" sz="600" b="1" dirty="0" err="1"/>
                <a:t>sub</a:t>
              </a:r>
              <a:r>
                <a:rPr lang="fr-FR" sz="600" b="1" dirty="0"/>
                <a:t>-clade</a:t>
              </a:r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608934" y="795362"/>
              <a:ext cx="2071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I</a:t>
              </a:r>
            </a:p>
          </p:txBody>
        </p:sp>
        <p:cxnSp>
          <p:nvCxnSpPr>
            <p:cNvPr id="21" name="Connecteur droit 20"/>
            <p:cNvCxnSpPr/>
            <p:nvPr/>
          </p:nvCxnSpPr>
          <p:spPr>
            <a:xfrm>
              <a:off x="619904" y="813508"/>
              <a:ext cx="16515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ZoneTexte 60"/>
            <p:cNvSpPr txBox="1"/>
            <p:nvPr/>
          </p:nvSpPr>
          <p:spPr>
            <a:xfrm>
              <a:off x="608926" y="887032"/>
              <a:ext cx="2071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I</a:t>
              </a:r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608918" y="978702"/>
              <a:ext cx="2071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I</a:t>
              </a:r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608910" y="1070372"/>
              <a:ext cx="2071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I</a:t>
              </a:r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608902" y="1162042"/>
              <a:ext cx="2071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I</a:t>
              </a: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599284" y="164436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II</a:t>
              </a:r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599284" y="1732456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II</a:t>
              </a:r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599284" y="1820544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II</a:t>
              </a:r>
            </a:p>
          </p:txBody>
        </p:sp>
      </p:grpSp>
      <p:grpSp>
        <p:nvGrpSpPr>
          <p:cNvPr id="72" name="Groupe 71"/>
          <p:cNvGrpSpPr/>
          <p:nvPr/>
        </p:nvGrpSpPr>
        <p:grpSpPr>
          <a:xfrm>
            <a:off x="953945" y="697721"/>
            <a:ext cx="10581138" cy="1656148"/>
            <a:chOff x="953945" y="697721"/>
            <a:chExt cx="10581138" cy="1656148"/>
          </a:xfrm>
        </p:grpSpPr>
        <p:grpSp>
          <p:nvGrpSpPr>
            <p:cNvPr id="42" name="Groupe 41"/>
            <p:cNvGrpSpPr/>
            <p:nvPr/>
          </p:nvGrpSpPr>
          <p:grpSpPr>
            <a:xfrm>
              <a:off x="953945" y="697721"/>
              <a:ext cx="10581138" cy="1647681"/>
              <a:chOff x="1117544" y="2351411"/>
              <a:chExt cx="11084758" cy="1730256"/>
            </a:xfrm>
          </p:grpSpPr>
          <p:pic>
            <p:nvPicPr>
              <p:cNvPr id="8" name="Image 7"/>
              <p:cNvPicPr>
                <a:picLocks noChangeAspect="1"/>
              </p:cNvPicPr>
              <p:nvPr/>
            </p:nvPicPr>
            <p:blipFill rotWithShape="1">
              <a:blip r:embed="rId2"/>
              <a:srcRect l="9083" t="25944" r="4205" b="70446"/>
              <a:stretch/>
            </p:blipFill>
            <p:spPr>
              <a:xfrm>
                <a:off x="1132661" y="3398044"/>
                <a:ext cx="11039515" cy="258477"/>
              </a:xfrm>
              <a:prstGeom prst="rect">
                <a:avLst/>
              </a:prstGeom>
            </p:spPr>
          </p:pic>
          <p:sp>
            <p:nvSpPr>
              <p:cNvPr id="17" name="Rectangle 16"/>
              <p:cNvSpPr/>
              <p:nvPr/>
            </p:nvSpPr>
            <p:spPr>
              <a:xfrm>
                <a:off x="3273028" y="3388707"/>
                <a:ext cx="1310084" cy="267815"/>
              </a:xfrm>
              <a:prstGeom prst="rect">
                <a:avLst/>
              </a:prstGeom>
              <a:solidFill>
                <a:srgbClr val="7030A0">
                  <a:alpha val="38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4471194" y="3400265"/>
                <a:ext cx="654843" cy="249685"/>
              </a:xfrm>
              <a:prstGeom prst="rect">
                <a:avLst/>
              </a:prstGeom>
              <a:solidFill>
                <a:srgbClr val="FFC000">
                  <a:alpha val="38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grpSp>
            <p:nvGrpSpPr>
              <p:cNvPr id="39" name="Groupe 38"/>
              <p:cNvGrpSpPr/>
              <p:nvPr/>
            </p:nvGrpSpPr>
            <p:grpSpPr>
              <a:xfrm>
                <a:off x="1117544" y="3163461"/>
                <a:ext cx="11050642" cy="84328"/>
                <a:chOff x="1008062" y="3744937"/>
                <a:chExt cx="11014153" cy="86869"/>
              </a:xfrm>
            </p:grpSpPr>
            <p:pic>
              <p:nvPicPr>
                <p:cNvPr id="14" name="Image 13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9065" t="24701" r="4236" b="74302"/>
                <a:stretch/>
              </p:blipFill>
              <p:spPr>
                <a:xfrm>
                  <a:off x="1008062" y="3759172"/>
                  <a:ext cx="11014153" cy="71437"/>
                </a:xfrm>
                <a:prstGeom prst="rect">
                  <a:avLst/>
                </a:prstGeom>
              </p:spPr>
            </p:pic>
            <p:sp>
              <p:nvSpPr>
                <p:cNvPr id="15" name="Rectangle 14"/>
                <p:cNvSpPr/>
                <p:nvPr/>
              </p:nvSpPr>
              <p:spPr>
                <a:xfrm>
                  <a:off x="3167063" y="3744937"/>
                  <a:ext cx="1290637" cy="80076"/>
                </a:xfrm>
                <a:prstGeom prst="rect">
                  <a:avLst/>
                </a:prstGeom>
                <a:solidFill>
                  <a:srgbClr val="7030A0">
                    <a:alpha val="38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6" name="Rectangle 15"/>
                <p:cNvSpPr/>
                <p:nvPr/>
              </p:nvSpPr>
              <p:spPr>
                <a:xfrm>
                  <a:off x="4351338" y="3752431"/>
                  <a:ext cx="649287" cy="79375"/>
                </a:xfrm>
                <a:prstGeom prst="rect">
                  <a:avLst/>
                </a:prstGeom>
                <a:solidFill>
                  <a:srgbClr val="FFC000">
                    <a:alpha val="38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grpSp>
            <p:nvGrpSpPr>
              <p:cNvPr id="38" name="Groupe 37"/>
              <p:cNvGrpSpPr/>
              <p:nvPr/>
            </p:nvGrpSpPr>
            <p:grpSpPr>
              <a:xfrm>
                <a:off x="1119356" y="2351411"/>
                <a:ext cx="11082946" cy="738785"/>
                <a:chOff x="1119356" y="2351411"/>
                <a:chExt cx="11082946" cy="738785"/>
              </a:xfrm>
            </p:grpSpPr>
            <p:pic>
              <p:nvPicPr>
                <p:cNvPr id="33" name="Image 32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5946" t="15679" r="7142" b="74022"/>
                <a:stretch/>
              </p:blipFill>
              <p:spPr>
                <a:xfrm>
                  <a:off x="1119356" y="2351411"/>
                  <a:ext cx="11082946" cy="738785"/>
                </a:xfrm>
                <a:prstGeom prst="rect">
                  <a:avLst/>
                </a:prstGeom>
              </p:spPr>
            </p:pic>
            <p:sp>
              <p:nvSpPr>
                <p:cNvPr id="34" name="Rectangle 33"/>
                <p:cNvSpPr/>
                <p:nvPr/>
              </p:nvSpPr>
              <p:spPr>
                <a:xfrm>
                  <a:off x="3208990" y="2524666"/>
                  <a:ext cx="1320544" cy="554106"/>
                </a:xfrm>
                <a:prstGeom prst="rect">
                  <a:avLst/>
                </a:prstGeom>
                <a:solidFill>
                  <a:srgbClr val="7030A0">
                    <a:alpha val="38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5" name="Rectangle 34"/>
                <p:cNvSpPr/>
                <p:nvPr/>
              </p:nvSpPr>
              <p:spPr>
                <a:xfrm>
                  <a:off x="5906606" y="2512158"/>
                  <a:ext cx="615240" cy="563994"/>
                </a:xfrm>
                <a:prstGeom prst="rect">
                  <a:avLst/>
                </a:prstGeom>
                <a:solidFill>
                  <a:srgbClr val="FFC000">
                    <a:alpha val="38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grpSp>
            <p:nvGrpSpPr>
              <p:cNvPr id="41" name="Groupe 40"/>
              <p:cNvGrpSpPr/>
              <p:nvPr/>
            </p:nvGrpSpPr>
            <p:grpSpPr>
              <a:xfrm>
                <a:off x="1135987" y="3810280"/>
                <a:ext cx="11032199" cy="271387"/>
                <a:chOff x="1010575" y="4384777"/>
                <a:chExt cx="11032199" cy="271387"/>
              </a:xfrm>
            </p:grpSpPr>
            <p:pic>
              <p:nvPicPr>
                <p:cNvPr id="9" name="Image 8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9109" t="29900" r="4237" b="66621"/>
                <a:stretch/>
              </p:blipFill>
              <p:spPr>
                <a:xfrm>
                  <a:off x="1010575" y="4402204"/>
                  <a:ext cx="11032199" cy="249094"/>
                </a:xfrm>
                <a:prstGeom prst="rect">
                  <a:avLst/>
                </a:prstGeom>
              </p:spPr>
            </p:pic>
            <p:sp>
              <p:nvSpPr>
                <p:cNvPr id="19" name="Rectangle 18"/>
                <p:cNvSpPr/>
                <p:nvPr/>
              </p:nvSpPr>
              <p:spPr>
                <a:xfrm>
                  <a:off x="3094038" y="4384777"/>
                  <a:ext cx="1310084" cy="267815"/>
                </a:xfrm>
                <a:prstGeom prst="rect">
                  <a:avLst/>
                </a:prstGeom>
                <a:solidFill>
                  <a:srgbClr val="7030A0">
                    <a:alpha val="38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0" name="Rectangle 19"/>
                <p:cNvSpPr/>
                <p:nvPr/>
              </p:nvSpPr>
              <p:spPr>
                <a:xfrm>
                  <a:off x="4269582" y="4389309"/>
                  <a:ext cx="673893" cy="266855"/>
                </a:xfrm>
                <a:prstGeom prst="rect">
                  <a:avLst/>
                </a:prstGeom>
                <a:solidFill>
                  <a:srgbClr val="FFC000">
                    <a:alpha val="38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</p:grpSp>
        <p:sp>
          <p:nvSpPr>
            <p:cNvPr id="71" name="Rectangle 70"/>
            <p:cNvSpPr/>
            <p:nvPr/>
          </p:nvSpPr>
          <p:spPr>
            <a:xfrm>
              <a:off x="953945" y="2264569"/>
              <a:ext cx="6523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70" name="Image 69"/>
            <p:cNvPicPr>
              <a:picLocks noChangeAspect="1"/>
            </p:cNvPicPr>
            <p:nvPr/>
          </p:nvPicPr>
          <p:blipFill rotWithShape="1">
            <a:blip r:embed="rId2"/>
            <a:srcRect l="9109" t="29765" r="90515" b="69017"/>
            <a:stretch/>
          </p:blipFill>
          <p:spPr>
            <a:xfrm>
              <a:off x="971551" y="2270792"/>
              <a:ext cx="45719" cy="83077"/>
            </a:xfrm>
            <a:prstGeom prst="rect">
              <a:avLst/>
            </a:prstGeom>
          </p:spPr>
        </p:pic>
      </p:grpSp>
      <p:sp>
        <p:nvSpPr>
          <p:cNvPr id="75" name="ZoneTexte 74"/>
          <p:cNvSpPr txBox="1"/>
          <p:nvPr/>
        </p:nvSpPr>
        <p:spPr>
          <a:xfrm>
            <a:off x="46780" y="650557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Fig. S1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4485860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47</TotalTime>
  <Words>69</Words>
  <Application>Microsoft Office PowerPoint</Application>
  <PresentationFormat>Grand écran</PresentationFormat>
  <Paragraphs>32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yril Bontemps</dc:creator>
  <cp:lastModifiedBy>Pierre Leblond</cp:lastModifiedBy>
  <cp:revision>36</cp:revision>
  <dcterms:created xsi:type="dcterms:W3CDTF">2020-02-18T14:22:03Z</dcterms:created>
  <dcterms:modified xsi:type="dcterms:W3CDTF">2020-03-19T13:03:16Z</dcterms:modified>
</cp:coreProperties>
</file>